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2"/>
  </p:notesMasterIdLst>
  <p:sldIdLst>
    <p:sldId id="264" r:id="rId2"/>
    <p:sldId id="266" r:id="rId3"/>
    <p:sldId id="273" r:id="rId4"/>
    <p:sldId id="274" r:id="rId5"/>
    <p:sldId id="275" r:id="rId6"/>
    <p:sldId id="276" r:id="rId7"/>
    <p:sldId id="277" r:id="rId8"/>
    <p:sldId id="278" r:id="rId9"/>
    <p:sldId id="279" r:id="rId10"/>
    <p:sldId id="280" r:id="rId11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201"/>
    <p:restoredTop sz="94658"/>
  </p:normalViewPr>
  <p:slideViewPr>
    <p:cSldViewPr snapToGrid="0" snapToObjects="1">
      <p:cViewPr varScale="1">
        <p:scale>
          <a:sx n="82" d="100"/>
          <a:sy n="82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F849D9-FB48-1244-96D8-A212369655FE}" type="datetimeFigureOut">
              <a:rPr lang="en-US" smtClean="0"/>
              <a:t>8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D5DB80-C29D-5441-92AA-1B1A986D7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895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27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55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82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09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37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64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891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19" algn="l" defTabSz="91425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050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3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52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275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089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901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395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963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120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41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765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E0113-4328-3847-A0E9-DF16AAE3A9B8}" type="datetimeFigureOut">
              <a:rPr lang="en-US" smtClean="0"/>
              <a:t>8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145FA-A027-0649-8869-4392EA676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27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0AE908-025C-2E86-26F0-2E181D436509}"/>
              </a:ext>
            </a:extLst>
          </p:cNvPr>
          <p:cNvSpPr txBox="1"/>
          <p:nvPr/>
        </p:nvSpPr>
        <p:spPr>
          <a:xfrm>
            <a:off x="1934740" y="3033135"/>
            <a:ext cx="3902927" cy="1323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999" dirty="0"/>
              <a:t>Supplemental Tables</a:t>
            </a:r>
          </a:p>
        </p:txBody>
      </p:sp>
    </p:spTree>
    <p:extLst>
      <p:ext uri="{BB962C8B-B14F-4D97-AF65-F5344CB8AC3E}">
        <p14:creationId xmlns:p14="http://schemas.microsoft.com/office/powerpoint/2010/main" val="5378189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5DECD37-3E48-242F-A592-49E2CC8739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677" y="711350"/>
            <a:ext cx="6676464" cy="93470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7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200" y="7082119"/>
            <a:ext cx="3359523" cy="29762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55015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4B3BC00-3C38-BE6C-C8F0-FFFE9C65BD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9547678"/>
              </p:ext>
            </p:extLst>
          </p:nvPr>
        </p:nvGraphicFramePr>
        <p:xfrm>
          <a:off x="913951" y="634021"/>
          <a:ext cx="5943600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5943600" imgH="2743200" progId="Word.Document.12">
                  <p:embed/>
                </p:oleObj>
              </mc:Choice>
              <mc:Fallback>
                <p:oleObj name="Document" r:id="rId2" imgW="5943600" imgH="27432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13951" y="634021"/>
                        <a:ext cx="5943600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12915637-8CD7-284A-4CE2-665B932A1F57}"/>
              </a:ext>
            </a:extLst>
          </p:cNvPr>
          <p:cNvSpPr txBox="1"/>
          <p:nvPr/>
        </p:nvSpPr>
        <p:spPr>
          <a:xfrm>
            <a:off x="913951" y="3238721"/>
            <a:ext cx="5507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cs typeface="Times New Roman" panose="02020603050405020304" pitchFamily="18" charset="0"/>
              </a:rPr>
              <a:t>Supplemental Table: 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crocirculation parameters stratified by CKD Stage.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16B1B5D-FBD1-E693-6949-9BBD0BA85F55}"/>
              </a:ext>
            </a:extLst>
          </p:cNvPr>
          <p:cNvSpPr txBox="1"/>
          <p:nvPr/>
        </p:nvSpPr>
        <p:spPr>
          <a:xfrm>
            <a:off x="470688" y="418451"/>
            <a:ext cx="953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. Table 1</a:t>
            </a:r>
          </a:p>
        </p:txBody>
      </p:sp>
    </p:spTree>
    <p:extLst>
      <p:ext uri="{BB962C8B-B14F-4D97-AF65-F5344CB8AC3E}">
        <p14:creationId xmlns:p14="http://schemas.microsoft.com/office/powerpoint/2010/main" val="786952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0AE908-025C-2E86-26F0-2E181D436509}"/>
              </a:ext>
            </a:extLst>
          </p:cNvPr>
          <p:cNvSpPr txBox="1"/>
          <p:nvPr/>
        </p:nvSpPr>
        <p:spPr>
          <a:xfrm>
            <a:off x="1934740" y="3033135"/>
            <a:ext cx="3902927" cy="1323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999" dirty="0"/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19484268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B912EC7-6FCE-BE94-94A2-4864106D35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676" y="651733"/>
            <a:ext cx="6719047" cy="940666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200" y="7207624"/>
            <a:ext cx="3359523" cy="28507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6309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CDC5AD7-C33A-CACD-923E-4DD0D86789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8328" y="663388"/>
            <a:ext cx="6467395" cy="905435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200" y="6974541"/>
            <a:ext cx="3359523" cy="30838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1724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DF8F77B-A492-D210-FDA4-461F5304D6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677" y="708660"/>
            <a:ext cx="6678386" cy="93497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3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200" y="7171765"/>
            <a:ext cx="3359523" cy="28866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3424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A018B19-20DF-31D5-C179-C3180DE2FB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677" y="803911"/>
            <a:ext cx="6610349" cy="925448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4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200" y="7171765"/>
            <a:ext cx="3359523" cy="28866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18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357CA74-62B9-2238-3180-4D5FBA610E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177" y="799638"/>
            <a:ext cx="6338046" cy="887326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5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200" y="7171765"/>
            <a:ext cx="3359523" cy="28866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7577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941A03B-769F-AA69-EE75-16CED00CEF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146" y="709991"/>
            <a:ext cx="6434107" cy="90077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D815A-B9B5-F45C-966F-29D3D6DDDB5C}"/>
              </a:ext>
            </a:extLst>
          </p:cNvPr>
          <p:cNvSpPr txBox="1"/>
          <p:nvPr/>
        </p:nvSpPr>
        <p:spPr>
          <a:xfrm>
            <a:off x="215153" y="340659"/>
            <a:ext cx="1413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. Figure 6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E64A33-BDDF-367B-F3A3-9647FCA1F68D}"/>
              </a:ext>
            </a:extLst>
          </p:cNvPr>
          <p:cNvSpPr/>
          <p:nvPr/>
        </p:nvSpPr>
        <p:spPr>
          <a:xfrm>
            <a:off x="3886199" y="6831106"/>
            <a:ext cx="3359523" cy="28866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7089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78</TotalTime>
  <Words>46</Words>
  <Application>Microsoft Macintosh PowerPoint</Application>
  <PresentationFormat>Custom</PresentationFormat>
  <Paragraphs>11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ulcea, Jacob</dc:creator>
  <cp:lastModifiedBy>Niculcea, Jacob</cp:lastModifiedBy>
  <cp:revision>68</cp:revision>
  <dcterms:created xsi:type="dcterms:W3CDTF">2024-12-26T16:47:02Z</dcterms:created>
  <dcterms:modified xsi:type="dcterms:W3CDTF">2025-08-03T02:13:01Z</dcterms:modified>
</cp:coreProperties>
</file>